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9144000" cy="6858000" type="screen4x3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95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2F8AF"/>
    <a:srgbClr val="F7B259"/>
    <a:srgbClr val="41DADF"/>
    <a:srgbClr val="60E09C"/>
    <a:srgbClr val="8FCB93"/>
    <a:srgbClr val="88EE24"/>
    <a:srgbClr val="9CFE89"/>
    <a:srgbClr val="66E289"/>
    <a:srgbClr val="5AD8EF"/>
    <a:srgbClr val="F95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558" y="66"/>
      </p:cViewPr>
      <p:guideLst>
        <p:guide orient="horz" pos="2160"/>
        <p:guide pos="295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49892" y="1279525"/>
            <a:ext cx="460586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143000" y="1322962"/>
            <a:ext cx="6858000" cy="2187001"/>
          </a:xfrm>
        </p:spPr>
        <p:txBody>
          <a:bodyPr anchor="b">
            <a:normAutofit/>
          </a:bodyPr>
          <a:lstStyle>
            <a:lvl1pPr algn="ctr">
              <a:defRPr sz="6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628650" y="551543"/>
            <a:ext cx="78867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85775" y="1825625"/>
            <a:ext cx="7886700" cy="4351338"/>
          </a:xfrm>
        </p:spPr>
        <p:txBody>
          <a:bodyPr>
            <a:normAutofit/>
          </a:bodyPr>
          <a:lstStyle>
            <a:lvl1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3751117"/>
            <a:ext cx="5491163" cy="811357"/>
          </a:xfrm>
        </p:spPr>
        <p:txBody>
          <a:bodyPr anchor="b">
            <a:normAutofit/>
          </a:bodyPr>
          <a:lstStyle>
            <a:lvl1pPr>
              <a:defRPr sz="4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610028"/>
            <a:ext cx="5491163" cy="647555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>
            <a:normAutofit/>
          </a:bodyPr>
          <a:lstStyle>
            <a:lvl1pPr>
              <a:defRPr sz="24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857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862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744961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615609"/>
            <a:ext cx="3868340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744961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615609"/>
            <a:ext cx="3887391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8650" y="2766219"/>
            <a:ext cx="7886700" cy="1325563"/>
          </a:xfrm>
        </p:spPr>
        <p:txBody>
          <a:bodyPr>
            <a:normAutofit/>
          </a:bodyPr>
          <a:lstStyle>
            <a:lvl1pPr algn="ctr">
              <a:defRPr sz="48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485060" y="127000"/>
            <a:ext cx="3123900" cy="1600200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3888000" y="766354"/>
            <a:ext cx="4363031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88870" y="2057400"/>
            <a:ext cx="31239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0/3/13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cxnSp>
        <p:nvCxnSpPr>
          <p:cNvPr id="8" name="直接连接符 7" hidden="1"/>
          <p:cNvCxnSpPr/>
          <p:nvPr userDrawn="1"/>
        </p:nvCxnSpPr>
        <p:spPr>
          <a:xfrm>
            <a:off x="557213" y="434340"/>
            <a:ext cx="0" cy="13912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368363" y="365125"/>
            <a:ext cx="1146987" cy="5811838"/>
          </a:xfrm>
        </p:spPr>
        <p:txBody>
          <a:bodyPr vert="eaVert">
            <a:normAutofit/>
          </a:bodyPr>
          <a:lstStyle>
            <a:lvl1pPr>
              <a:defRPr sz="36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6659969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ags" Target="../tags/tag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>
          <a:gsLst>
            <a:gs pos="0">
              <a:schemeClr val="bg1">
                <a:lumMod val="95000"/>
              </a:schemeClr>
            </a:gs>
            <a:gs pos="100000">
              <a:schemeClr val="tx2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KSO_TEMPLATE" hidden="1"/>
          <p:cNvSpPr/>
          <p:nvPr userDrawn="1">
            <p:custDataLst>
              <p:tags r:id="rId14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970174" y="446638"/>
            <a:ext cx="108241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Lycopen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934508" y="2054196"/>
            <a:ext cx="1933543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β-Apo-8'-carotena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908221" y="1235733"/>
            <a:ext cx="1212191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β-Caroten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897000" y="2070430"/>
            <a:ext cx="122341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Zeaxanth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483425" y="2885434"/>
            <a:ext cx="2050561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rocetin dialdehyd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348774" y="3709319"/>
            <a:ext cx="230704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rocetin semialdehyd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998933" y="4534423"/>
            <a:ext cx="979755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roce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816301" y="5638403"/>
            <a:ext cx="1347738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rocin</a:t>
            </a:r>
            <a:r>
              <a:rPr lang="en-US" altLang="zh-CN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s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I–V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箭头连接符 2"/>
          <p:cNvCxnSpPr>
            <a:cxnSpLocks/>
            <a:stCxn id="5" idx="2"/>
            <a:endCxn id="7" idx="0"/>
          </p:cNvCxnSpPr>
          <p:nvPr/>
        </p:nvCxnSpPr>
        <p:spPr>
          <a:xfrm>
            <a:off x="4511380" y="815970"/>
            <a:ext cx="2937" cy="419763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>
            <a:cxnSpLocks/>
            <a:stCxn id="7" idx="2"/>
            <a:endCxn id="8" idx="0"/>
          </p:cNvCxnSpPr>
          <p:nvPr/>
        </p:nvCxnSpPr>
        <p:spPr>
          <a:xfrm flipH="1">
            <a:off x="4508706" y="1605065"/>
            <a:ext cx="5611" cy="465365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>
            <a:cxnSpLocks/>
            <a:stCxn id="8" idx="2"/>
            <a:endCxn id="9" idx="0"/>
          </p:cNvCxnSpPr>
          <p:nvPr/>
        </p:nvCxnSpPr>
        <p:spPr>
          <a:xfrm>
            <a:off x="4508706" y="2439762"/>
            <a:ext cx="0" cy="445672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>
            <a:cxnSpLocks/>
            <a:stCxn id="9" idx="2"/>
            <a:endCxn id="10" idx="0"/>
          </p:cNvCxnSpPr>
          <p:nvPr/>
        </p:nvCxnSpPr>
        <p:spPr>
          <a:xfrm flipH="1">
            <a:off x="4502295" y="3254766"/>
            <a:ext cx="6411" cy="454553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>
            <a:cxnSpLocks/>
            <a:stCxn id="10" idx="2"/>
            <a:endCxn id="11" idx="0"/>
          </p:cNvCxnSpPr>
          <p:nvPr/>
        </p:nvCxnSpPr>
        <p:spPr>
          <a:xfrm flipH="1">
            <a:off x="4488811" y="4078651"/>
            <a:ext cx="13484" cy="455772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>
            <a:cxnSpLocks/>
            <a:stCxn id="11" idx="2"/>
            <a:endCxn id="12" idx="0"/>
          </p:cNvCxnSpPr>
          <p:nvPr/>
        </p:nvCxnSpPr>
        <p:spPr>
          <a:xfrm>
            <a:off x="4488811" y="4903755"/>
            <a:ext cx="1359" cy="734648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>
            <a:cxnSpLocks/>
            <a:stCxn id="7" idx="1"/>
            <a:endCxn id="6" idx="0"/>
          </p:cNvCxnSpPr>
          <p:nvPr/>
        </p:nvCxnSpPr>
        <p:spPr>
          <a:xfrm flipH="1">
            <a:off x="2901280" y="1420399"/>
            <a:ext cx="1006941" cy="633797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>
            <a:stCxn id="6" idx="2"/>
            <a:endCxn id="9" idx="1"/>
          </p:cNvCxnSpPr>
          <p:nvPr/>
        </p:nvCxnSpPr>
        <p:spPr>
          <a:xfrm>
            <a:off x="2901280" y="2423528"/>
            <a:ext cx="582145" cy="646572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4537059" y="868409"/>
            <a:ext cx="1031051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LCYB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502295" y="1620144"/>
            <a:ext cx="889987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BCH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488810" y="2435148"/>
            <a:ext cx="109517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jCCD4a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319570" y="1432975"/>
            <a:ext cx="109517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jCCD4a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116314" y="2608435"/>
            <a:ext cx="109517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jCCD4a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906697" y="1596097"/>
            <a:ext cx="1095172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jCCD4a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cxnSp>
        <p:nvCxnSpPr>
          <p:cNvPr id="26" name="曲线连接符 25"/>
          <p:cNvCxnSpPr>
            <a:cxnSpLocks/>
            <a:stCxn id="5" idx="3"/>
            <a:endCxn id="9" idx="3"/>
          </p:cNvCxnSpPr>
          <p:nvPr/>
        </p:nvCxnSpPr>
        <p:spPr>
          <a:xfrm>
            <a:off x="5052586" y="631304"/>
            <a:ext cx="481400" cy="2438796"/>
          </a:xfrm>
          <a:prstGeom prst="curvedConnector3">
            <a:avLst>
              <a:gd name="adj1" fmla="val 175511"/>
            </a:avLst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4502295" y="3277785"/>
            <a:ext cx="1441420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ALDH2C3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476589" y="4082841"/>
            <a:ext cx="1441420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ALDH2C3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476589" y="4899388"/>
            <a:ext cx="1492716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UGT94E13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488810" y="5216909"/>
            <a:ext cx="1364476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GjUGT74F8</a:t>
            </a:r>
            <a:endParaRPr lang="en-US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11B7F5E4-77E6-4DD6-8B08-B240F81B374E}"/>
              </a:ext>
            </a:extLst>
          </p:cNvPr>
          <p:cNvSpPr/>
          <p:nvPr/>
        </p:nvSpPr>
        <p:spPr>
          <a:xfrm>
            <a:off x="1807052" y="6298324"/>
            <a:ext cx="5390485" cy="320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1. The potential crocin biosynthetic pathway in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. </a:t>
            </a:r>
            <a:r>
              <a:rPr lang="en-US" altLang="zh-CN" sz="1400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jasminoides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zh-CN" sz="1400" dirty="0">
              <a:effectLst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01798598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BEAUTIFY_FLAG" val="#wm#"/>
  <p:tag name="KSO_WM_TEMPLATE_CATEGORY" val="custom"/>
  <p:tag name="KSO_WM_TEMPLATE_INDEX" val="20187308"/>
  <p:tag name="KSO_WM_TEMPLATE_THUMBS_INDEX" val="1、2、3、6、8、10、11、12、15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187308"/>
</p:tagLst>
</file>

<file path=ppt/theme/theme1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E6E4E4"/>
      </a:dk2>
      <a:lt2>
        <a:srgbClr val="FFFFFF"/>
      </a:lt2>
      <a:accent1>
        <a:srgbClr val="477DEA"/>
      </a:accent1>
      <a:accent2>
        <a:srgbClr val="9B9B9B"/>
      </a:accent2>
      <a:accent3>
        <a:srgbClr val="F3B745"/>
      </a:accent3>
      <a:accent4>
        <a:srgbClr val="477EE7"/>
      </a:accent4>
      <a:accent5>
        <a:srgbClr val="4BA151"/>
      </a:accent5>
      <a:accent6>
        <a:srgbClr val="E9403C"/>
      </a:accent6>
      <a:hlink>
        <a:srgbClr val="0563C1"/>
      </a:hlink>
      <a:folHlink>
        <a:srgbClr val="954D72"/>
      </a:folHlink>
    </a:clrScheme>
    <a:fontScheme name="2019空白演示文档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</TotalTime>
  <Words>38</Words>
  <Application>Microsoft Office PowerPoint</Application>
  <PresentationFormat>全屏显示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ingsoft</dc:creator>
  <cp:lastModifiedBy>Administrator</cp:lastModifiedBy>
  <cp:revision>470</cp:revision>
  <dcterms:created xsi:type="dcterms:W3CDTF">2017-08-03T09:01:00Z</dcterms:created>
  <dcterms:modified xsi:type="dcterms:W3CDTF">2020-03-13T08:27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